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899953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BB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7FE2773-6CB9-4134-8165-86901B1E1900}" v="55" dt="2025-12-18T10:53:21.4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7" d="100"/>
          <a:sy n="87" d="100"/>
        </p:scale>
        <p:origin x="1296" y="67"/>
      </p:cViewPr>
      <p:guideLst>
        <p:guide orient="horz" pos="2160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olo' De Biase" userId="bb248559-009a-46cd-8dcd-1efcf179a387" providerId="ADAL" clId="{623EA0C4-DE5B-40E2-9F9E-0252A261D1A8}"/>
    <pc:docChg chg="undo custSel addSld delSld modSld">
      <pc:chgData name="Nicolo' De Biase" userId="bb248559-009a-46cd-8dcd-1efcf179a387" providerId="ADAL" clId="{623EA0C4-DE5B-40E2-9F9E-0252A261D1A8}" dt="2025-12-02T09:38:35.310" v="241" actId="1076"/>
      <pc:docMkLst>
        <pc:docMk/>
      </pc:docMkLst>
      <pc:sldChg chg="addSp modSp add mod">
        <pc:chgData name="Nicolo' De Biase" userId="bb248559-009a-46cd-8dcd-1efcf179a387" providerId="ADAL" clId="{623EA0C4-DE5B-40E2-9F9E-0252A261D1A8}" dt="2025-12-02T09:38:35.310" v="241" actId="1076"/>
        <pc:sldMkLst>
          <pc:docMk/>
          <pc:sldMk cId="503593814" sldId="261"/>
        </pc:sldMkLst>
      </pc:sldChg>
    </pc:docChg>
  </pc:docChgLst>
  <pc:docChgLst>
    <pc:chgData name="Lavinia Del Punta" userId="f149d8e1-e363-404d-827b-886ba70782f2" providerId="ADAL" clId="{B7A0C727-5D4D-422A-93EB-3B13B4654896}"/>
    <pc:docChg chg="undo custSel modSld">
      <pc:chgData name="Lavinia Del Punta" userId="f149d8e1-e363-404d-827b-886ba70782f2" providerId="ADAL" clId="{B7A0C727-5D4D-422A-93EB-3B13B4654896}" dt="2025-12-18T10:53:30.382" v="64" actId="1076"/>
      <pc:docMkLst>
        <pc:docMk/>
      </pc:docMkLst>
      <pc:sldChg chg="addSp delSp modSp mod">
        <pc:chgData name="Lavinia Del Punta" userId="f149d8e1-e363-404d-827b-886ba70782f2" providerId="ADAL" clId="{B7A0C727-5D4D-422A-93EB-3B13B4654896}" dt="2025-12-18T10:53:30.382" v="64" actId="1076"/>
        <pc:sldMkLst>
          <pc:docMk/>
          <pc:sldMk cId="503593814" sldId="261"/>
        </pc:sldMkLst>
        <pc:spChg chg="add mod">
          <ac:chgData name="Lavinia Del Punta" userId="f149d8e1-e363-404d-827b-886ba70782f2" providerId="ADAL" clId="{B7A0C727-5D4D-422A-93EB-3B13B4654896}" dt="2025-12-02T14:57:10.738" v="47" actId="1076"/>
          <ac:spMkLst>
            <pc:docMk/>
            <pc:sldMk cId="503593814" sldId="261"/>
            <ac:spMk id="36" creationId="{B3382415-B51D-D4F0-2079-3100FE6F8462}"/>
          </ac:spMkLst>
        </pc:spChg>
        <pc:spChg chg="add mod">
          <ac:chgData name="Lavinia Del Punta" userId="f149d8e1-e363-404d-827b-886ba70782f2" providerId="ADAL" clId="{B7A0C727-5D4D-422A-93EB-3B13B4654896}" dt="2025-12-02T14:57:47.038" v="62" actId="1036"/>
          <ac:spMkLst>
            <pc:docMk/>
            <pc:sldMk cId="503593814" sldId="261"/>
            <ac:spMk id="37" creationId="{EDBE2F48-79C3-0144-6C8C-C85EC72DA7D3}"/>
          </ac:spMkLst>
        </pc:spChg>
        <pc:spChg chg="mod">
          <ac:chgData name="Lavinia Del Punta" userId="f149d8e1-e363-404d-827b-886ba70782f2" providerId="ADAL" clId="{B7A0C727-5D4D-422A-93EB-3B13B4654896}" dt="2025-12-02T14:57:40.490" v="53" actId="1076"/>
          <ac:spMkLst>
            <pc:docMk/>
            <pc:sldMk cId="503593814" sldId="261"/>
            <ac:spMk id="40" creationId="{704C28DB-2E93-C207-B4C3-959D72DAFE7E}"/>
          </ac:spMkLst>
        </pc:spChg>
        <pc:spChg chg="mod">
          <ac:chgData name="Lavinia Del Punta" userId="f149d8e1-e363-404d-827b-886ba70782f2" providerId="ADAL" clId="{B7A0C727-5D4D-422A-93EB-3B13B4654896}" dt="2025-12-02T14:57:40.490" v="53" actId="1076"/>
          <ac:spMkLst>
            <pc:docMk/>
            <pc:sldMk cId="503593814" sldId="261"/>
            <ac:spMk id="41" creationId="{03C31371-9DDB-8BAA-7DCF-640399AFC2F6}"/>
          </ac:spMkLst>
        </pc:spChg>
        <pc:spChg chg="mod">
          <ac:chgData name="Lavinia Del Punta" userId="f149d8e1-e363-404d-827b-886ba70782f2" providerId="ADAL" clId="{B7A0C727-5D4D-422A-93EB-3B13B4654896}" dt="2025-12-02T14:57:40.490" v="53" actId="1076"/>
          <ac:spMkLst>
            <pc:docMk/>
            <pc:sldMk cId="503593814" sldId="261"/>
            <ac:spMk id="42" creationId="{DF4E5205-593B-7060-BF06-3BA453DD8177}"/>
          </ac:spMkLst>
        </pc:spChg>
        <pc:spChg chg="mod">
          <ac:chgData name="Lavinia Del Punta" userId="f149d8e1-e363-404d-827b-886ba70782f2" providerId="ADAL" clId="{B7A0C727-5D4D-422A-93EB-3B13B4654896}" dt="2025-12-18T10:53:30.382" v="64" actId="1076"/>
          <ac:spMkLst>
            <pc:docMk/>
            <pc:sldMk cId="503593814" sldId="261"/>
            <ac:spMk id="47" creationId="{4B4D0C7E-8C36-3906-DF84-7EC6A41B4627}"/>
          </ac:spMkLst>
        </pc:spChg>
        <pc:grpChg chg="add mod">
          <ac:chgData name="Lavinia Del Punta" userId="f149d8e1-e363-404d-827b-886ba70782f2" providerId="ADAL" clId="{B7A0C727-5D4D-422A-93EB-3B13B4654896}" dt="2025-12-02T14:57:40.490" v="53" actId="1076"/>
          <ac:grpSpMkLst>
            <pc:docMk/>
            <pc:sldMk cId="503593814" sldId="261"/>
            <ac:grpSpMk id="38" creationId="{592FF381-38B1-1EA4-D2B0-6A5B74D27847}"/>
          </ac:grpSpMkLst>
        </pc:grpChg>
        <pc:grpChg chg="add mod">
          <ac:chgData name="Lavinia Del Punta" userId="f149d8e1-e363-404d-827b-886ba70782f2" providerId="ADAL" clId="{B7A0C727-5D4D-422A-93EB-3B13B4654896}" dt="2025-12-18T10:53:21.491" v="63" actId="1076"/>
          <ac:grpSpMkLst>
            <pc:docMk/>
            <pc:sldMk cId="503593814" sldId="261"/>
            <ac:grpSpMk id="45" creationId="{085607D5-386D-92C6-E5E3-CAFE3F67CBFF}"/>
          </ac:grpSpMkLst>
        </pc:grpChg>
        <pc:picChg chg="mod">
          <ac:chgData name="Lavinia Del Punta" userId="f149d8e1-e363-404d-827b-886ba70782f2" providerId="ADAL" clId="{B7A0C727-5D4D-422A-93EB-3B13B4654896}" dt="2025-12-02T14:57:40.490" v="53" actId="1076"/>
          <ac:picMkLst>
            <pc:docMk/>
            <pc:sldMk cId="503593814" sldId="261"/>
            <ac:picMk id="39" creationId="{38AB5FAA-4BB8-2CA5-2D5F-DA8D88B01AC6}"/>
          </ac:picMkLst>
        </pc:picChg>
        <pc:picChg chg="mod">
          <ac:chgData name="Lavinia Del Punta" userId="f149d8e1-e363-404d-827b-886ba70782f2" providerId="ADAL" clId="{B7A0C727-5D4D-422A-93EB-3B13B4654896}" dt="2025-12-18T10:53:21.491" v="63" actId="1076"/>
          <ac:picMkLst>
            <pc:docMk/>
            <pc:sldMk cId="503593814" sldId="261"/>
            <ac:picMk id="46" creationId="{B0F1B775-B7E3-0A45-E357-9A5080271147}"/>
          </ac:picMkLst>
        </pc:picChg>
        <pc:cxnChg chg="mod">
          <ac:chgData name="Lavinia Del Punta" userId="f149d8e1-e363-404d-827b-886ba70782f2" providerId="ADAL" clId="{B7A0C727-5D4D-422A-93EB-3B13B4654896}" dt="2025-12-02T14:57:40.490" v="53" actId="1076"/>
          <ac:cxnSpMkLst>
            <pc:docMk/>
            <pc:sldMk cId="503593814" sldId="261"/>
            <ac:cxnSpMk id="43" creationId="{44E5A1D1-14C2-5380-D23A-529A49550A5C}"/>
          </ac:cxnSpMkLst>
        </pc:cxnChg>
        <pc:cxnChg chg="mod">
          <ac:chgData name="Lavinia Del Punta" userId="f149d8e1-e363-404d-827b-886ba70782f2" providerId="ADAL" clId="{B7A0C727-5D4D-422A-93EB-3B13B4654896}" dt="2025-12-02T14:57:40.490" v="53" actId="1076"/>
          <ac:cxnSpMkLst>
            <pc:docMk/>
            <pc:sldMk cId="503593814" sldId="261"/>
            <ac:cxnSpMk id="44" creationId="{9D22D326-8CEB-E247-4C24-88F6A49A42F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22363"/>
            <a:ext cx="7649607" cy="2387600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602038"/>
            <a:ext cx="6749654" cy="165576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718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9606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65125"/>
            <a:ext cx="194052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65125"/>
            <a:ext cx="5709082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671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0186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09740"/>
            <a:ext cx="7762102" cy="2852737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589465"/>
            <a:ext cx="7762102" cy="150018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>
                    <a:tint val="82000"/>
                  </a:schemeClr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82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82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7408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825625"/>
            <a:ext cx="3824804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825625"/>
            <a:ext cx="3824804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0540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65127"/>
            <a:ext cx="7762102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681163"/>
            <a:ext cx="3807226" cy="82391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505075"/>
            <a:ext cx="3807226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681163"/>
            <a:ext cx="3825976" cy="82391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505075"/>
            <a:ext cx="3825976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9212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0761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8584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57200"/>
            <a:ext cx="2902585" cy="16002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987427"/>
            <a:ext cx="4556016" cy="487362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057400"/>
            <a:ext cx="2902585" cy="3811588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281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57200"/>
            <a:ext cx="2902585" cy="16002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987427"/>
            <a:ext cx="4556016" cy="487362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057400"/>
            <a:ext cx="2902585" cy="3811588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9049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65127"/>
            <a:ext cx="776210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825625"/>
            <a:ext cx="776210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356352"/>
            <a:ext cx="202489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296F83-89E2-48AD-9A54-573EC34494D3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356352"/>
            <a:ext cx="303734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356352"/>
            <a:ext cx="202489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64E6BA-44BE-4501-98BB-5FCAC112EA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1226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3382415-B51D-D4F0-2079-3100FE6F8462}"/>
              </a:ext>
            </a:extLst>
          </p:cNvPr>
          <p:cNvSpPr txBox="1"/>
          <p:nvPr/>
        </p:nvSpPr>
        <p:spPr>
          <a:xfrm>
            <a:off x="2759259" y="287868"/>
            <a:ext cx="3481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Calibri" panose="020F0502020204030204" pitchFamily="34" charset="0"/>
                <a:cs typeface="Calibri" panose="020F0502020204030204" pitchFamily="34" charset="0"/>
              </a:rPr>
              <a:t>A) </a:t>
            </a:r>
            <a:r>
              <a:rPr lang="it-IT" b="1" dirty="0" err="1">
                <a:latin typeface="Calibri" panose="020F0502020204030204" pitchFamily="34" charset="0"/>
                <a:cs typeface="Calibri" panose="020F0502020204030204" pitchFamily="34" charset="0"/>
              </a:rPr>
              <a:t>Calibration</a:t>
            </a:r>
            <a:r>
              <a:rPr lang="it-IT" b="1" dirty="0">
                <a:latin typeface="Calibri" panose="020F0502020204030204" pitchFamily="34" charset="0"/>
                <a:cs typeface="Calibri" panose="020F0502020204030204" pitchFamily="34" charset="0"/>
              </a:rPr>
              <a:t> curve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EDBE2F48-79C3-0144-6C8C-C85EC72DA7D3}"/>
              </a:ext>
            </a:extLst>
          </p:cNvPr>
          <p:cNvSpPr txBox="1"/>
          <p:nvPr/>
        </p:nvSpPr>
        <p:spPr>
          <a:xfrm>
            <a:off x="2899866" y="4883989"/>
            <a:ext cx="3481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Calibri" panose="020F0502020204030204" pitchFamily="34" charset="0"/>
                <a:cs typeface="Calibri" panose="020F0502020204030204" pitchFamily="34" charset="0"/>
              </a:rPr>
              <a:t>B) </a:t>
            </a:r>
            <a:r>
              <a:rPr lang="it-IT" b="1" dirty="0" err="1">
                <a:latin typeface="Calibri" panose="020F0502020204030204" pitchFamily="34" charset="0"/>
                <a:cs typeface="Calibri" panose="020F0502020204030204" pitchFamily="34" charset="0"/>
              </a:rPr>
              <a:t>Probability</a:t>
            </a:r>
            <a:r>
              <a:rPr lang="it-IT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b="1" dirty="0" err="1">
                <a:latin typeface="Calibri" panose="020F0502020204030204" pitchFamily="34" charset="0"/>
                <a:cs typeface="Calibri" panose="020F0502020204030204" pitchFamily="34" charset="0"/>
              </a:rPr>
              <a:t>distribution</a:t>
            </a:r>
            <a:r>
              <a:rPr lang="it-IT" b="1" dirty="0">
                <a:latin typeface="Calibri" panose="020F0502020204030204" pitchFamily="34" charset="0"/>
                <a:cs typeface="Calibri" panose="020F0502020204030204" pitchFamily="34" charset="0"/>
              </a:rPr>
              <a:t> plot</a:t>
            </a:r>
          </a:p>
        </p:txBody>
      </p:sp>
      <p:grpSp>
        <p:nvGrpSpPr>
          <p:cNvPr id="38" name="Gruppo 37">
            <a:extLst>
              <a:ext uri="{FF2B5EF4-FFF2-40B4-BE49-F238E27FC236}">
                <a16:creationId xmlns:a16="http://schemas.microsoft.com/office/drawing/2014/main" id="{592FF381-38B1-1EA4-D2B0-6A5B74D27847}"/>
              </a:ext>
            </a:extLst>
          </p:cNvPr>
          <p:cNvGrpSpPr/>
          <p:nvPr/>
        </p:nvGrpSpPr>
        <p:grpSpPr>
          <a:xfrm>
            <a:off x="1314374" y="472534"/>
            <a:ext cx="6370788" cy="4326786"/>
            <a:chOff x="73418" y="1373926"/>
            <a:chExt cx="5942312" cy="3883388"/>
          </a:xfrm>
        </p:grpSpPr>
        <p:pic>
          <p:nvPicPr>
            <p:cNvPr id="39" name="Picture 8">
              <a:extLst>
                <a:ext uri="{FF2B5EF4-FFF2-40B4-BE49-F238E27FC236}">
                  <a16:creationId xmlns:a16="http://schemas.microsoft.com/office/drawing/2014/main" id="{38AB5FAA-4BB8-2CA5-2D5F-DA8D88B01AC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32" b="21339"/>
            <a:stretch>
              <a:fillRect/>
            </a:stretch>
          </p:blipFill>
          <p:spPr bwMode="auto">
            <a:xfrm>
              <a:off x="73418" y="1581186"/>
              <a:ext cx="5942312" cy="35800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704C28DB-2E93-C207-B4C3-959D72DAFE7E}"/>
                </a:ext>
              </a:extLst>
            </p:cNvPr>
            <p:cNvSpPr txBox="1"/>
            <p:nvPr/>
          </p:nvSpPr>
          <p:spPr>
            <a:xfrm>
              <a:off x="1389745" y="4949537"/>
              <a:ext cx="35908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Mean </a:t>
              </a:r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redicted</a:t>
              </a:r>
              <a:r>
                <a:rPr lang="it-IT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robability</a:t>
              </a:r>
              <a:endParaRPr lang="it-IT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03C31371-9DDB-8BAA-7DCF-640399AFC2F6}"/>
                </a:ext>
              </a:extLst>
            </p:cNvPr>
            <p:cNvSpPr txBox="1"/>
            <p:nvPr/>
          </p:nvSpPr>
          <p:spPr>
            <a:xfrm rot="16200000">
              <a:off x="-1568130" y="3015474"/>
              <a:ext cx="35908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Fraction</a:t>
              </a:r>
              <a:r>
                <a:rPr lang="it-IT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 of </a:t>
              </a:r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ositives</a:t>
              </a:r>
              <a:endParaRPr lang="it-IT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2" name="Rettangolo con angoli arrotondati 41">
              <a:extLst>
                <a:ext uri="{FF2B5EF4-FFF2-40B4-BE49-F238E27FC236}">
                  <a16:creationId xmlns:a16="http://schemas.microsoft.com/office/drawing/2014/main" id="{DF4E5205-593B-7060-BF06-3BA453DD8177}"/>
                </a:ext>
              </a:extLst>
            </p:cNvPr>
            <p:cNvSpPr/>
            <p:nvPr/>
          </p:nvSpPr>
          <p:spPr>
            <a:xfrm>
              <a:off x="4910773" y="4114503"/>
              <a:ext cx="961534" cy="546755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  <p:cxnSp>
          <p:nvCxnSpPr>
            <p:cNvPr id="43" name="Connettore diritto 42">
              <a:extLst>
                <a:ext uri="{FF2B5EF4-FFF2-40B4-BE49-F238E27FC236}">
                  <a16:creationId xmlns:a16="http://schemas.microsoft.com/office/drawing/2014/main" id="{44E5A1D1-14C2-5380-D23A-529A49550A5C}"/>
                </a:ext>
              </a:extLst>
            </p:cNvPr>
            <p:cNvCxnSpPr>
              <a:cxnSpLocks/>
            </p:cNvCxnSpPr>
            <p:nvPr/>
          </p:nvCxnSpPr>
          <p:spPr>
            <a:xfrm>
              <a:off x="5808869" y="4028661"/>
              <a:ext cx="0" cy="632597"/>
            </a:xfrm>
            <a:prstGeom prst="line">
              <a:avLst/>
            </a:prstGeom>
            <a:ln w="12700">
              <a:solidFill>
                <a:srgbClr val="BBBBBB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ttore diritto 43">
              <a:extLst>
                <a:ext uri="{FF2B5EF4-FFF2-40B4-BE49-F238E27FC236}">
                  <a16:creationId xmlns:a16="http://schemas.microsoft.com/office/drawing/2014/main" id="{9D22D326-8CEB-E247-4C24-88F6A49A42FB}"/>
                </a:ext>
              </a:extLst>
            </p:cNvPr>
            <p:cNvCxnSpPr>
              <a:cxnSpLocks/>
            </p:cNvCxnSpPr>
            <p:nvPr/>
          </p:nvCxnSpPr>
          <p:spPr>
            <a:xfrm>
              <a:off x="4910773" y="4611372"/>
              <a:ext cx="961534" cy="0"/>
            </a:xfrm>
            <a:prstGeom prst="line">
              <a:avLst/>
            </a:prstGeom>
            <a:ln w="12700">
              <a:solidFill>
                <a:srgbClr val="BBBBBB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uppo 44">
            <a:extLst>
              <a:ext uri="{FF2B5EF4-FFF2-40B4-BE49-F238E27FC236}">
                <a16:creationId xmlns:a16="http://schemas.microsoft.com/office/drawing/2014/main" id="{085607D5-386D-92C6-E5E3-CAFE3F67CBFF}"/>
              </a:ext>
            </a:extLst>
          </p:cNvPr>
          <p:cNvGrpSpPr/>
          <p:nvPr/>
        </p:nvGrpSpPr>
        <p:grpSpPr>
          <a:xfrm>
            <a:off x="1354999" y="5410385"/>
            <a:ext cx="6570751" cy="1249026"/>
            <a:chOff x="6161215" y="5368537"/>
            <a:chExt cx="6030785" cy="934732"/>
          </a:xfrm>
        </p:grpSpPr>
        <p:pic>
          <p:nvPicPr>
            <p:cNvPr id="46" name="Picture 8">
              <a:extLst>
                <a:ext uri="{FF2B5EF4-FFF2-40B4-BE49-F238E27FC236}">
                  <a16:creationId xmlns:a16="http://schemas.microsoft.com/office/drawing/2014/main" id="{B0F1B775-B7E3-0A45-E357-9A508027114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22" t="82832" b="178"/>
            <a:stretch>
              <a:fillRect/>
            </a:stretch>
          </p:blipFill>
          <p:spPr bwMode="auto">
            <a:xfrm>
              <a:off x="6161215" y="5368537"/>
              <a:ext cx="6030785" cy="9347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id="{4B4D0C7E-8C36-3906-DF84-7EC6A41B4627}"/>
                </a:ext>
              </a:extLst>
            </p:cNvPr>
            <p:cNvSpPr txBox="1"/>
            <p:nvPr/>
          </p:nvSpPr>
          <p:spPr>
            <a:xfrm>
              <a:off x="7390476" y="5995492"/>
              <a:ext cx="35908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redicted</a:t>
              </a:r>
              <a:r>
                <a:rPr lang="it-IT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robability</a:t>
              </a:r>
              <a:r>
                <a:rPr lang="it-IT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it-IT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distribution</a:t>
              </a:r>
              <a:endParaRPr lang="it-IT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035938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18</Words>
  <Application>Microsoft Office PowerPoint</Application>
  <PresentationFormat>Personalizzato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olo' De Biase</dc:creator>
  <cp:lastModifiedBy>Lavinia Del Punta</cp:lastModifiedBy>
  <cp:revision>1</cp:revision>
  <dcterms:created xsi:type="dcterms:W3CDTF">2025-12-02T09:26:59Z</dcterms:created>
  <dcterms:modified xsi:type="dcterms:W3CDTF">2025-12-18T10:53:30Z</dcterms:modified>
</cp:coreProperties>
</file>